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8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39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3F8E9-9CBE-4185-B5F3-FDA4FB97A80A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DE254-612F-439A-BE63-05D035A5D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75600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3F8E9-9CBE-4185-B5F3-FDA4FB97A80A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DE254-612F-439A-BE63-05D035A5D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0897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3F8E9-9CBE-4185-B5F3-FDA4FB97A80A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DE254-612F-439A-BE63-05D035A5D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53861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3F8E9-9CBE-4185-B5F3-FDA4FB97A80A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DE254-612F-439A-BE63-05D035A5D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0050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3F8E9-9CBE-4185-B5F3-FDA4FB97A80A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DE254-612F-439A-BE63-05D035A5D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528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3F8E9-9CBE-4185-B5F3-FDA4FB97A80A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DE254-612F-439A-BE63-05D035A5D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62627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3F8E9-9CBE-4185-B5F3-FDA4FB97A80A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DE254-612F-439A-BE63-05D035A5D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14088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3F8E9-9CBE-4185-B5F3-FDA4FB97A80A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DE254-612F-439A-BE63-05D035A5D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4014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3F8E9-9CBE-4185-B5F3-FDA4FB97A80A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DE254-612F-439A-BE63-05D035A5D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225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3F8E9-9CBE-4185-B5F3-FDA4FB97A80A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DE254-612F-439A-BE63-05D035A5D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4942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3F8E9-9CBE-4185-B5F3-FDA4FB97A80A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DE254-612F-439A-BE63-05D035A5D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0159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63F8E9-9CBE-4185-B5F3-FDA4FB97A80A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3DE254-612F-439A-BE63-05D035A5D5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44304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4.mp4"/><Relationship Id="rId1" Type="http://schemas.microsoft.com/office/2007/relationships/media" Target="../media/media4.mp4"/><Relationship Id="rId4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5.mp4"/><Relationship Id="rId1" Type="http://schemas.microsoft.com/office/2007/relationships/media" Target="../media/media5.mp4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Supplemental Video 1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 smtClean="0"/>
              <a:t>Representative angiographies at 1, 6, 26, 52, and 104 weeks post-implantatio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04643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1 Week</a:t>
            </a:r>
            <a:endParaRPr lang="en-US" dirty="0"/>
          </a:p>
        </p:txBody>
      </p:sp>
      <p:pic>
        <p:nvPicPr>
          <p:cNvPr id="5" name="012317 Angio Movie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5334000" y="0"/>
            <a:ext cx="6858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169088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6</a:t>
            </a:r>
            <a:r>
              <a:rPr lang="en-US" dirty="0" smtClean="0"/>
              <a:t> Week</a:t>
            </a:r>
            <a:endParaRPr lang="en-US" dirty="0"/>
          </a:p>
        </p:txBody>
      </p:sp>
      <p:pic>
        <p:nvPicPr>
          <p:cNvPr id="3" name="022717 Angio Movie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5334000" y="0"/>
            <a:ext cx="6858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30380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26 Week</a:t>
            </a:r>
            <a:endParaRPr lang="en-US" dirty="0"/>
          </a:p>
        </p:txBody>
      </p:sp>
      <p:pic>
        <p:nvPicPr>
          <p:cNvPr id="3" name="170719 Angio Movie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5334000" y="0"/>
            <a:ext cx="6858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430951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52 Week</a:t>
            </a:r>
            <a:endParaRPr lang="en-US" dirty="0"/>
          </a:p>
        </p:txBody>
      </p:sp>
      <p:pic>
        <p:nvPicPr>
          <p:cNvPr id="3" name="180109 Angio Movie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5334000" y="0"/>
            <a:ext cx="6858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0487427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104 Week</a:t>
            </a:r>
            <a:endParaRPr lang="en-US" dirty="0"/>
          </a:p>
        </p:txBody>
      </p:sp>
      <p:pic>
        <p:nvPicPr>
          <p:cNvPr id="3" name="190211 Angio Movie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5334000" y="0"/>
            <a:ext cx="6858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145553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28</Words>
  <Application>Microsoft Office PowerPoint</Application>
  <PresentationFormat>Widescreen</PresentationFormat>
  <Paragraphs>7</Paragraphs>
  <Slides>6</Slides>
  <Notes>0</Notes>
  <HiddenSlides>0</HiddenSlides>
  <MMClips>5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Supplemental Video 1</vt:lpstr>
      <vt:lpstr>1 Week</vt:lpstr>
      <vt:lpstr>6 Week</vt:lpstr>
      <vt:lpstr>26 Week</vt:lpstr>
      <vt:lpstr>52 Week</vt:lpstr>
      <vt:lpstr>104 Week</vt:lpstr>
    </vt:vector>
  </TitlesOfParts>
  <Company>NCHR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lurry Imaging</dc:title>
  <dc:creator>Blum, Kevin</dc:creator>
  <cp:lastModifiedBy>Blum, Kevin</cp:lastModifiedBy>
  <cp:revision>7</cp:revision>
  <dcterms:created xsi:type="dcterms:W3CDTF">2020-12-30T14:22:22Z</dcterms:created>
  <dcterms:modified xsi:type="dcterms:W3CDTF">2021-04-01T19:52:10Z</dcterms:modified>
</cp:coreProperties>
</file>